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3293915-59F8-4574-AFF9-58BEDF2808E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424443"/>
          <a:ext cx="6451600" cy="4414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4788000" imgH="3276000" progId="Prism5.Document">
                  <p:embed/>
                </p:oleObj>
              </mc:Choice>
              <mc:Fallback>
                <p:oleObj name="Prism Project" r:id="rId2" imgW="4788000" imgH="3276000" progId="Prism5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3293915-59F8-4574-AFF9-58BEDF2808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424443"/>
                        <a:ext cx="6451600" cy="4414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50AF69E-8101-4856-82DB-0D9F2048A15A}"/>
              </a:ext>
            </a:extLst>
          </p:cNvPr>
          <p:cNvSpPr txBox="1"/>
          <p:nvPr/>
        </p:nvSpPr>
        <p:spPr>
          <a:xfrm>
            <a:off x="1842088" y="184774"/>
            <a:ext cx="1237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3</a:t>
            </a:r>
            <a:r>
              <a: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C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705229-ABAE-4E1E-AA33-6D0180FD1890}"/>
              </a:ext>
            </a:extLst>
          </p:cNvPr>
          <p:cNvSpPr txBox="1"/>
          <p:nvPr/>
        </p:nvSpPr>
        <p:spPr>
          <a:xfrm>
            <a:off x="810555" y="4460910"/>
            <a:ext cx="406728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Fi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N biofilm altered the frequencies of SWC3a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3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ventional dendritic cells in blood and intestinal tissu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 means frequencies of B cells ± SEM. Gnotobiotic pigs were transplanted with human infant fecal microbiota (HIFM), at 4 days of age, post-HIFM transplantation day (PTD) 0. Probiotic was given to the respective groups at PTD 11, followed by challenge with virulent human rotavirus (HRV) on PTD 13/post-challenge day (PCD) 0 and pigs were euthanized on PTD 27/PCD 14. </a:t>
            </a:r>
          </a:p>
        </p:txBody>
      </p:sp>
    </p:spTree>
    <p:extLst>
      <p:ext uri="{BB962C8B-B14F-4D97-AF65-F5344CB8AC3E}">
        <p14:creationId xmlns:p14="http://schemas.microsoft.com/office/powerpoint/2010/main" val="3406584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10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8:51Z</dcterms:modified>
</cp:coreProperties>
</file>